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58" d="100"/>
          <a:sy n="58" d="100"/>
        </p:scale>
        <p:origin x="78" y="10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023D416-C068-4F45-94E4-0864F01D96AF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E2AAFD-05FE-42E9-AA61-40BA89C32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5625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幻灯片图像占位符 1">
            <a:extLst>
              <a:ext uri="{FF2B5EF4-FFF2-40B4-BE49-F238E27FC236}">
                <a16:creationId xmlns:a16="http://schemas.microsoft.com/office/drawing/2014/main" id="{55FE3D51-37BE-4CB9-89E8-5E1F6F8C147C}"/>
              </a:ext>
            </a:extLst>
          </p:cNvPr>
          <p:cNvSpPr>
            <a:spLocks noGrp="1" noRot="1" noChangeAspect="1" noChangeArrowheads="1" noTextEdit="1"/>
          </p:cNvSpPr>
          <p:nvPr>
            <p:ph type="sldImg" idx="4294967295"/>
          </p:nvPr>
        </p:nvSpPr>
        <p:spPr>
          <a:ln>
            <a:miter lim="800000"/>
          </a:ln>
        </p:spPr>
      </p:sp>
      <p:sp>
        <p:nvSpPr>
          <p:cNvPr id="6147" name="文本占位符 2">
            <a:extLst>
              <a:ext uri="{FF2B5EF4-FFF2-40B4-BE49-F238E27FC236}">
                <a16:creationId xmlns:a16="http://schemas.microsoft.com/office/drawing/2014/main" id="{F2AD8320-1ED0-4803-B2EE-EAB4A485FF7E}"/>
              </a:ext>
            </a:extLst>
          </p:cNvPr>
          <p:cNvSpPr>
            <a:spLocks noGrp="1" noChangeArrowheads="1"/>
          </p:cNvSpPr>
          <p:nvPr>
            <p:ph type="body" idx="4294967295"/>
          </p:nvPr>
        </p:nvSpPr>
        <p:spPr/>
        <p:txBody>
          <a:bodyPr/>
          <a:lstStyle/>
          <a:p>
            <a:pPr eaLnBrk="1" hangingPunct="1"/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6D841C-3A39-491A-BEB4-1A8735FDFC2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BD42507-3F47-495D-AAF3-B2EE3305688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B1B42F-2D31-42F5-A34D-01A8672F60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D2460-AA4D-4DCF-83ED-AEE0CF3F99F5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3CCA97-39D0-49B0-90EC-396A12A763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B8834E-7428-4F35-B118-623522C4B2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4476B-DDEA-456F-A657-46CDA6A7F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9787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7D4756-C3EE-44E9-9CDD-96AC393D51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D3F22EB-998C-4ECC-9FF8-A60A996135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D4E43F-8092-462E-9E5C-930A9C4933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D2460-AA4D-4DCF-83ED-AEE0CF3F99F5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867D2B-F72C-4928-B009-5C4E0618D0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D302FE-79F7-4C54-BA9A-AF8DD24C5C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4476B-DDEA-456F-A657-46CDA6A7F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77789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0F73601-C954-4417-9C41-8BCFD641705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A86D165-E6EE-4089-9E1E-86E0E6B594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808376-6235-4FC5-A433-1D4275523C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D2460-AA4D-4DCF-83ED-AEE0CF3F99F5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495B48-D699-4B4E-8572-4397F4DC9F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3CEC49-917A-450E-B460-6520E6A979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4476B-DDEA-456F-A657-46CDA6A7F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87148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5E69DB-8DF8-4FC0-B44F-BAB7D492C1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9E9A77-164D-430E-A0D4-60B5238753F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B4FAC8-61EB-4949-9320-C9C265D6DB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D2460-AA4D-4DCF-83ED-AEE0CF3F99F5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ACA8BD-6F11-477F-A909-093A1AF993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C3D642-4A28-4485-BA0B-6076FCBB4F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4476B-DDEA-456F-A657-46CDA6A7F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66243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AA58BB-AECC-4DE1-B2CA-901C67E1C4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57B0F2-3063-4230-8DA9-858986FFE1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B95C1D-E4B4-4A27-A232-92D6B8E33D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D2460-AA4D-4DCF-83ED-AEE0CF3F99F5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8B1188-5836-4796-8827-F67A43FB4E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F98F24-EFF6-4633-8971-4EA3DDCD36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4476B-DDEA-456F-A657-46CDA6A7F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3421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43E591-4DA4-47A1-B7AA-05D682B67E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97A6CF-C330-4DF0-915A-369AC13945C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5866FD-3B58-46A7-93F7-55B6F39AE7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2C42F12-EEEF-4C07-9D1F-346F913337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D2460-AA4D-4DCF-83ED-AEE0CF3F99F5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467F0B9-17AA-45A1-BB9E-39A63F467A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3F8677C-A9DC-4A13-A517-C11E1B86F4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4476B-DDEA-456F-A657-46CDA6A7F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65042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8E1159-D986-4116-91BE-F48DF4A6BF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3CFA84C-26C7-43BD-AF40-4ECC42BF40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731F26F-30B9-4D10-A8C2-87C1D1BF49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13D6041-702C-4DB2-A898-7B0F043EE00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0CFB11F-E9B0-4E4B-99C5-F351E8E991E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8B7F3D6-3736-41BD-9AC0-1B725D8F67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D2460-AA4D-4DCF-83ED-AEE0CF3F99F5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04DA949-DD36-4D41-9860-8E4834E5E4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FD69EA0-A682-4A08-BD95-ADC2835527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4476B-DDEA-456F-A657-46CDA6A7F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13879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670FAD-1786-491B-B7A3-CD01E5C97A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070480D-6644-4822-A277-23B29F59B2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D2460-AA4D-4DCF-83ED-AEE0CF3F99F5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2568606-321B-4008-8AF4-03D881EAD1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E830641-1C8A-4320-A322-55894C03DB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4476B-DDEA-456F-A657-46CDA6A7F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43991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F9C90C0-DF57-41E0-A644-9E667338C0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D2460-AA4D-4DCF-83ED-AEE0CF3F99F5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1F815CC-7A9E-4B8B-BE53-65AFF43EA5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59D198C-7069-45D5-AC3F-FF77E0D14E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4476B-DDEA-456F-A657-46CDA6A7F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0287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ECC5D8-48E5-42B0-902B-65B6BA1CA4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DD5847-0267-473F-97EA-032DE1EFCA6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7CD5869-F84D-48FD-B137-9A8892876F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9A00241-B27F-4DA2-9CDF-E6EFD4E4CF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D2460-AA4D-4DCF-83ED-AEE0CF3F99F5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454645C-6668-45D3-B2EE-E8D25B9AF3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FE56DA-ECD3-400F-839C-0BA68685C4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4476B-DDEA-456F-A657-46CDA6A7F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4460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40E0D8-0F89-4194-969E-EE683FA09E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83B3790-B564-41E7-9188-19CA766FB31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EF39ED5-2E83-480C-BA4B-126609B9D1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E11002B-D84D-4EE5-AC55-6C03507229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D2460-AA4D-4DCF-83ED-AEE0CF3F99F5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9667B3-A7C7-4BB3-A1DA-9AFAFC970F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43D2B4-DA9A-464B-A834-DCE7BC5BCC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4476B-DDEA-456F-A657-46CDA6A7F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2191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5017EF0-FD2C-492F-BB67-7827D7FA60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8155A12-8272-4316-9891-A48A3742A4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C62D68-7EC5-41CF-81E1-F297B16C54D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5D2460-AA4D-4DCF-83ED-AEE0CF3F99F5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640E5A-9A65-42EE-915B-E804E349C9D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AAF770-780B-4BE2-AB05-16F2AF72032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94476B-DDEA-456F-A657-46CDA6A7F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31248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文本框 2">
            <a:extLst>
              <a:ext uri="{FF2B5EF4-FFF2-40B4-BE49-F238E27FC236}">
                <a16:creationId xmlns:a16="http://schemas.microsoft.com/office/drawing/2014/main" id="{CF7DA6F2-4350-49B5-96D6-AA361469D42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64819" y="6077231"/>
            <a:ext cx="4462362" cy="3604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zh-CN" altLang="en-US" sz="1742" b="1" dirty="0">
                <a:latin typeface="Times New Roman" panose="02020603050405020304" pitchFamily="18" charset="0"/>
              </a:rPr>
              <a:t>Figure </a:t>
            </a:r>
            <a:r>
              <a:rPr lang="en-US" altLang="zh-CN" sz="1742" b="1" dirty="0">
                <a:latin typeface="Times New Roman" panose="02020603050405020304" pitchFamily="18" charset="0"/>
              </a:rPr>
              <a:t>S</a:t>
            </a:r>
            <a:r>
              <a:rPr lang="zh-CN" altLang="en-US" sz="1742" b="1" dirty="0">
                <a:latin typeface="Times New Roman" panose="02020603050405020304" pitchFamily="18" charset="0"/>
              </a:rPr>
              <a:t>1</a:t>
            </a:r>
            <a:r>
              <a:rPr lang="zh-CN" altLang="en-US" sz="1742" dirty="0">
                <a:latin typeface="Times New Roman" panose="02020603050405020304" pitchFamily="18" charset="0"/>
              </a:rPr>
              <a:t>. Diagram of soil sampling</a:t>
            </a:r>
            <a:r>
              <a:rPr lang="en-US" altLang="zh-CN" sz="1742" dirty="0">
                <a:latin typeface="Times New Roman" panose="02020603050405020304" pitchFamily="18" charset="0"/>
              </a:rPr>
              <a:t> (0-50 cm).</a:t>
            </a:r>
            <a:endParaRPr lang="zh-CN" altLang="en-US" sz="1742" dirty="0">
              <a:latin typeface="Times New Roman" panose="02020603050405020304" pitchFamily="18" charset="0"/>
            </a:endParaRPr>
          </a:p>
        </p:txBody>
      </p:sp>
      <p:pic>
        <p:nvPicPr>
          <p:cNvPr id="4099" name="图片 2" descr="Figure 1A">
            <a:extLst>
              <a:ext uri="{FF2B5EF4-FFF2-40B4-BE49-F238E27FC236}">
                <a16:creationId xmlns:a16="http://schemas.microsoft.com/office/drawing/2014/main" id="{634BE825-1880-4E98-87B9-9D004CE9C13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64819" y="424395"/>
            <a:ext cx="4462362" cy="5574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文本框 2">
            <a:extLst>
              <a:ext uri="{FF2B5EF4-FFF2-40B4-BE49-F238E27FC236}">
                <a16:creationId xmlns:a16="http://schemas.microsoft.com/office/drawing/2014/main" id="{4E2076E1-4E12-4B02-A1C3-47EF259052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67741" y="4682455"/>
            <a:ext cx="10456211" cy="3604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zh-CN" altLang="en-US" sz="1742" b="1" dirty="0">
                <a:latin typeface="Times New Roman" panose="02020603050405020304" pitchFamily="18" charset="0"/>
              </a:rPr>
              <a:t>Figure </a:t>
            </a:r>
            <a:r>
              <a:rPr lang="en-US" altLang="zh-CN" sz="1742" b="1" dirty="0">
                <a:latin typeface="Times New Roman" panose="02020603050405020304" pitchFamily="18" charset="0"/>
              </a:rPr>
              <a:t>S</a:t>
            </a:r>
            <a:r>
              <a:rPr lang="zh-CN" altLang="en-US" sz="1742" b="1" dirty="0">
                <a:latin typeface="Times New Roman" panose="02020603050405020304" pitchFamily="18" charset="0"/>
              </a:rPr>
              <a:t>2.</a:t>
            </a:r>
            <a:r>
              <a:rPr lang="zh-CN" altLang="en-US" sz="1742" dirty="0">
                <a:latin typeface="Times New Roman" panose="02020603050405020304" pitchFamily="18" charset="0"/>
              </a:rPr>
              <a:t> Detail picture of </a:t>
            </a:r>
            <a:r>
              <a:rPr lang="zh-CN" altLang="en-US" sz="1742" i="1" dirty="0">
                <a:latin typeface="Times New Roman" panose="02020603050405020304" pitchFamily="18" charset="0"/>
              </a:rPr>
              <a:t>I. polycarpa</a:t>
            </a:r>
            <a:r>
              <a:rPr lang="zh-CN" altLang="en-US" sz="1742" dirty="0">
                <a:latin typeface="Times New Roman" panose="02020603050405020304" pitchFamily="18" charset="0"/>
              </a:rPr>
              <a:t> 'Yuji'. (</a:t>
            </a:r>
            <a:r>
              <a:rPr lang="en-US" altLang="zh-CN" sz="1742" dirty="0">
                <a:latin typeface="Times New Roman" panose="02020603050405020304" pitchFamily="18" charset="0"/>
              </a:rPr>
              <a:t>A</a:t>
            </a:r>
            <a:r>
              <a:rPr lang="zh-CN" altLang="en-US" sz="1742" dirty="0">
                <a:latin typeface="Times New Roman" panose="02020603050405020304" pitchFamily="18" charset="0"/>
              </a:rPr>
              <a:t>) Leaf; (</a:t>
            </a:r>
            <a:r>
              <a:rPr lang="en-US" altLang="zh-CN" sz="1742" dirty="0">
                <a:latin typeface="Times New Roman" panose="02020603050405020304" pitchFamily="18" charset="0"/>
              </a:rPr>
              <a:t>B</a:t>
            </a:r>
            <a:r>
              <a:rPr lang="zh-CN" altLang="en-US" sz="1742" dirty="0">
                <a:latin typeface="Times New Roman" panose="02020603050405020304" pitchFamily="18" charset="0"/>
              </a:rPr>
              <a:t>) Flowers; (</a:t>
            </a:r>
            <a:r>
              <a:rPr lang="en-US" altLang="zh-CN" sz="1742" dirty="0">
                <a:latin typeface="Times New Roman" panose="02020603050405020304" pitchFamily="18" charset="0"/>
              </a:rPr>
              <a:t>C</a:t>
            </a:r>
            <a:r>
              <a:rPr lang="zh-CN" altLang="en-US" sz="1742" dirty="0">
                <a:latin typeface="Times New Roman" panose="02020603050405020304" pitchFamily="18" charset="0"/>
              </a:rPr>
              <a:t>) Fruit</a:t>
            </a:r>
            <a:r>
              <a:rPr lang="en-US" altLang="zh-CN" sz="1742" dirty="0">
                <a:latin typeface="Times New Roman" panose="02020603050405020304" pitchFamily="18" charset="0"/>
              </a:rPr>
              <a:t> cluster;</a:t>
            </a:r>
            <a:r>
              <a:rPr lang="zh-CN" altLang="en-US" sz="1742" dirty="0">
                <a:latin typeface="Times New Roman" panose="02020603050405020304" pitchFamily="18" charset="0"/>
              </a:rPr>
              <a:t> (</a:t>
            </a:r>
            <a:r>
              <a:rPr lang="en-US" altLang="zh-CN" sz="1742" dirty="0">
                <a:latin typeface="Times New Roman" panose="02020603050405020304" pitchFamily="18" charset="0"/>
              </a:rPr>
              <a:t>D</a:t>
            </a:r>
            <a:r>
              <a:rPr lang="zh-CN" altLang="en-US" sz="1742" dirty="0">
                <a:latin typeface="Times New Roman" panose="02020603050405020304" pitchFamily="18" charset="0"/>
              </a:rPr>
              <a:t>) </a:t>
            </a:r>
            <a:r>
              <a:rPr lang="en-US" altLang="zh-CN" sz="1742" dirty="0">
                <a:latin typeface="Times New Roman" panose="02020603050405020304" pitchFamily="18" charset="0"/>
              </a:rPr>
              <a:t>Dried fruit and </a:t>
            </a:r>
            <a:r>
              <a:rPr lang="zh-CN" altLang="en-US" sz="1742" dirty="0">
                <a:latin typeface="Times New Roman" panose="02020603050405020304" pitchFamily="18" charset="0"/>
              </a:rPr>
              <a:t>Seeds.</a:t>
            </a:r>
          </a:p>
        </p:txBody>
      </p:sp>
      <p:pic>
        <p:nvPicPr>
          <p:cNvPr id="5123" name="图片 1" descr="Figure 2A">
            <a:extLst>
              <a:ext uri="{FF2B5EF4-FFF2-40B4-BE49-F238E27FC236}">
                <a16:creationId xmlns:a16="http://schemas.microsoft.com/office/drawing/2014/main" id="{188532AA-F8DC-4D2E-97FE-E52902215D8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67895" y="1280001"/>
            <a:ext cx="2122886" cy="283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4" name="图片 2" descr="Figure 2B">
            <a:extLst>
              <a:ext uri="{FF2B5EF4-FFF2-40B4-BE49-F238E27FC236}">
                <a16:creationId xmlns:a16="http://schemas.microsoft.com/office/drawing/2014/main" id="{B404A1D0-2435-467C-AC65-6D4E80B65DD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77" t="22543" r="19101"/>
          <a:stretch>
            <a:fillRect/>
          </a:stretch>
        </p:blipFill>
        <p:spPr bwMode="auto">
          <a:xfrm>
            <a:off x="3096771" y="1269248"/>
            <a:ext cx="3310289" cy="28448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5" name="图片 3" descr="Figure 2C">
            <a:extLst>
              <a:ext uri="{FF2B5EF4-FFF2-40B4-BE49-F238E27FC236}">
                <a16:creationId xmlns:a16="http://schemas.microsoft.com/office/drawing/2014/main" id="{842F1762-8472-4472-AD9F-20E513877A2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14587" y="1269248"/>
            <a:ext cx="1847924" cy="28540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6" name="图片 11" descr="1">
            <a:extLst>
              <a:ext uri="{FF2B5EF4-FFF2-40B4-BE49-F238E27FC236}">
                <a16:creationId xmlns:a16="http://schemas.microsoft.com/office/drawing/2014/main" id="{E501476C-AD28-43DD-A000-1703D6B00EA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525" t="29903" r="22404" b="13811"/>
          <a:stretch>
            <a:fillRect/>
          </a:stretch>
        </p:blipFill>
        <p:spPr bwMode="auto">
          <a:xfrm>
            <a:off x="8465430" y="1258496"/>
            <a:ext cx="2791087" cy="28540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" name="矩形 15">
            <a:extLst>
              <a:ext uri="{FF2B5EF4-FFF2-40B4-BE49-F238E27FC236}">
                <a16:creationId xmlns:a16="http://schemas.microsoft.com/office/drawing/2014/main" id="{A4303400-8F55-4928-BDC1-B94294CC6450}"/>
              </a:ext>
            </a:extLst>
          </p:cNvPr>
          <p:cNvSpPr/>
          <p:nvPr/>
        </p:nvSpPr>
        <p:spPr>
          <a:xfrm>
            <a:off x="2568354" y="3690136"/>
            <a:ext cx="422427" cy="423963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r>
              <a:rPr lang="en-US" altLang="zh-CN" sz="2322" noProof="1">
                <a:latin typeface="Times New Roman" panose="02020603050405020304" charset="0"/>
                <a:cs typeface="Times New Roman" panose="02020603050405020304" charset="0"/>
              </a:rPr>
              <a:t>A</a:t>
            </a: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D13220AD-42DB-40A5-AD2E-3EF5E0E7F9EA}"/>
              </a:ext>
            </a:extLst>
          </p:cNvPr>
          <p:cNvSpPr/>
          <p:nvPr/>
        </p:nvSpPr>
        <p:spPr>
          <a:xfrm>
            <a:off x="5984633" y="3690136"/>
            <a:ext cx="422427" cy="423963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r>
              <a:rPr lang="en-US" altLang="zh-CN" sz="2322" noProof="1">
                <a:latin typeface="Times New Roman" panose="02020603050405020304" charset="0"/>
                <a:cs typeface="Times New Roman" panose="02020603050405020304" charset="0"/>
              </a:rPr>
              <a:t>B</a:t>
            </a: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B8E641EB-20EA-430F-AE5E-3B429E54C044}"/>
              </a:ext>
            </a:extLst>
          </p:cNvPr>
          <p:cNvSpPr/>
          <p:nvPr/>
        </p:nvSpPr>
        <p:spPr>
          <a:xfrm>
            <a:off x="7940084" y="3699353"/>
            <a:ext cx="422426" cy="423963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r>
              <a:rPr lang="en-US" altLang="zh-CN" sz="2322" noProof="1">
                <a:latin typeface="Times New Roman" panose="02020603050405020304" charset="0"/>
                <a:cs typeface="Times New Roman" panose="02020603050405020304" charset="0"/>
              </a:rPr>
              <a:t>C</a:t>
            </a: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BD9594B8-4867-4840-BF7B-00FDB2163115}"/>
              </a:ext>
            </a:extLst>
          </p:cNvPr>
          <p:cNvSpPr/>
          <p:nvPr/>
        </p:nvSpPr>
        <p:spPr>
          <a:xfrm>
            <a:off x="10834091" y="3688601"/>
            <a:ext cx="422426" cy="423963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r>
              <a:rPr lang="en-US" altLang="zh-CN" sz="2322" noProof="1">
                <a:latin typeface="Times New Roman" panose="02020603050405020304" charset="0"/>
                <a:cs typeface="Times New Roman" panose="02020603050405020304" charset="0"/>
              </a:rPr>
              <a:t>D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0" name="文本框 2">
            <a:extLst>
              <a:ext uri="{FF2B5EF4-FFF2-40B4-BE49-F238E27FC236}">
                <a16:creationId xmlns:a16="http://schemas.microsoft.com/office/drawing/2014/main" id="{285DE24C-82E7-4A1D-AC67-0E5F8166DCF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08753" y="5519628"/>
            <a:ext cx="5933942" cy="3604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zh-CN" altLang="en-US" sz="1742" b="1" dirty="0">
                <a:latin typeface="Times New Roman" panose="02020603050405020304" pitchFamily="18" charset="0"/>
              </a:rPr>
              <a:t>Figure </a:t>
            </a:r>
            <a:r>
              <a:rPr lang="en-US" altLang="zh-CN" sz="1742" b="1" dirty="0">
                <a:latin typeface="Times New Roman" panose="02020603050405020304" pitchFamily="18" charset="0"/>
              </a:rPr>
              <a:t>S</a:t>
            </a:r>
            <a:r>
              <a:rPr lang="zh-CN" altLang="en-US" sz="1742" b="1" dirty="0">
                <a:latin typeface="Times New Roman" panose="02020603050405020304" pitchFamily="18" charset="0"/>
              </a:rPr>
              <a:t>3</a:t>
            </a:r>
            <a:r>
              <a:rPr lang="zh-CN" altLang="en-US" sz="1742" dirty="0">
                <a:latin typeface="Times New Roman" panose="02020603050405020304" pitchFamily="18" charset="0"/>
              </a:rPr>
              <a:t>. Fruit oil of </a:t>
            </a:r>
            <a:r>
              <a:rPr lang="zh-CN" altLang="en-US" sz="1742" i="1" dirty="0">
                <a:latin typeface="Times New Roman" panose="02020603050405020304" pitchFamily="18" charset="0"/>
              </a:rPr>
              <a:t>I. polycarpa</a:t>
            </a:r>
            <a:r>
              <a:rPr lang="zh-CN" altLang="en-US" sz="1742" dirty="0">
                <a:latin typeface="Times New Roman" panose="02020603050405020304" pitchFamily="18" charset="0"/>
              </a:rPr>
              <a:t> 'Yuji'</a:t>
            </a:r>
            <a:r>
              <a:rPr lang="en-US" altLang="zh-CN" sz="1742" dirty="0">
                <a:latin typeface="Times New Roman" panose="02020603050405020304" pitchFamily="18" charset="0"/>
              </a:rPr>
              <a:t> (Glass bottle 20 ml)</a:t>
            </a:r>
            <a:r>
              <a:rPr lang="zh-CN" altLang="en-US" sz="1742" dirty="0">
                <a:latin typeface="Times New Roman" panose="02020603050405020304" pitchFamily="18" charset="0"/>
              </a:rPr>
              <a:t>.</a:t>
            </a:r>
          </a:p>
        </p:txBody>
      </p:sp>
      <p:pic>
        <p:nvPicPr>
          <p:cNvPr id="7171" name="Picture 6">
            <a:extLst>
              <a:ext uri="{FF2B5EF4-FFF2-40B4-BE49-F238E27FC236}">
                <a16:creationId xmlns:a16="http://schemas.microsoft.com/office/drawing/2014/main" id="{EB71047A-4CA7-48F9-9964-4DD4AFCC43B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63744" y="1338373"/>
            <a:ext cx="2915512" cy="38893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73</Words>
  <Application>Microsoft Office PowerPoint</Application>
  <PresentationFormat>Widescreen</PresentationFormat>
  <Paragraphs>7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u Menglin</dc:creator>
  <cp:lastModifiedBy>Menglin Liu</cp:lastModifiedBy>
  <cp:revision>2</cp:revision>
  <dcterms:created xsi:type="dcterms:W3CDTF">2022-08-19T07:53:03Z</dcterms:created>
  <dcterms:modified xsi:type="dcterms:W3CDTF">2023-06-26T15:45:44Z</dcterms:modified>
</cp:coreProperties>
</file>